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55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G:\NDB&#12458;&#12540;&#12503;&#12531;&#12487;&#12540;&#12479;&#12398;&#20998;&#26512;\&#21407;&#31295;_%20&#21307;&#30274;&#36027;&#35036;&#21161;&#25919;&#31574;&#12392;&#12501;&#12483;&#21270;&#29289;&#27927;&#21475;\&#12464;&#12521;&#12501;&#20316;&#25104;&#29992;_bmcpb_revision_1130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FMR!$E$1:$E$2</c:f>
              <c:strCache>
                <c:ptCount val="2"/>
                <c:pt idx="1">
                  <c:v>2016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SFMR!$D$3:$D$49</c:f>
              <c:numCache>
                <c:formatCode>General</c:formatCode>
                <c:ptCount val="4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</c:numCache>
            </c:numRef>
          </c:cat>
          <c:val>
            <c:numRef>
              <c:f>SFMR!$E$3:$E$49</c:f>
              <c:numCache>
                <c:formatCode>General</c:formatCode>
                <c:ptCount val="47"/>
                <c:pt idx="0">
                  <c:v>22</c:v>
                </c:pt>
                <c:pt idx="1">
                  <c:v>4.5999999999999996</c:v>
                </c:pt>
                <c:pt idx="2">
                  <c:v>5.3</c:v>
                </c:pt>
                <c:pt idx="3">
                  <c:v>4.5999999999999996</c:v>
                </c:pt>
                <c:pt idx="4">
                  <c:v>70.8</c:v>
                </c:pt>
                <c:pt idx="5">
                  <c:v>9.1999999999999993</c:v>
                </c:pt>
                <c:pt idx="6">
                  <c:v>4.7</c:v>
                </c:pt>
                <c:pt idx="7">
                  <c:v>0.3</c:v>
                </c:pt>
                <c:pt idx="8">
                  <c:v>7</c:v>
                </c:pt>
                <c:pt idx="9">
                  <c:v>1.9</c:v>
                </c:pt>
                <c:pt idx="10">
                  <c:v>8.6999999999999993</c:v>
                </c:pt>
                <c:pt idx="11">
                  <c:v>3.3</c:v>
                </c:pt>
                <c:pt idx="12">
                  <c:v>0.2</c:v>
                </c:pt>
                <c:pt idx="13">
                  <c:v>0.2</c:v>
                </c:pt>
                <c:pt idx="14">
                  <c:v>63.1</c:v>
                </c:pt>
                <c:pt idx="15">
                  <c:v>33.700000000000003</c:v>
                </c:pt>
                <c:pt idx="16">
                  <c:v>0.6</c:v>
                </c:pt>
                <c:pt idx="17">
                  <c:v>5.9</c:v>
                </c:pt>
                <c:pt idx="18">
                  <c:v>0.8</c:v>
                </c:pt>
                <c:pt idx="19">
                  <c:v>16</c:v>
                </c:pt>
                <c:pt idx="20">
                  <c:v>23.1</c:v>
                </c:pt>
                <c:pt idx="21">
                  <c:v>13.9</c:v>
                </c:pt>
                <c:pt idx="22">
                  <c:v>21.2</c:v>
                </c:pt>
                <c:pt idx="23">
                  <c:v>2.6</c:v>
                </c:pt>
                <c:pt idx="24">
                  <c:v>9.1999999999999993</c:v>
                </c:pt>
                <c:pt idx="25">
                  <c:v>44.2</c:v>
                </c:pt>
                <c:pt idx="26">
                  <c:v>0.1</c:v>
                </c:pt>
                <c:pt idx="27">
                  <c:v>3.1</c:v>
                </c:pt>
                <c:pt idx="28">
                  <c:v>3.9</c:v>
                </c:pt>
                <c:pt idx="29">
                  <c:v>15.3</c:v>
                </c:pt>
                <c:pt idx="30">
                  <c:v>8.9</c:v>
                </c:pt>
                <c:pt idx="31">
                  <c:v>51</c:v>
                </c:pt>
                <c:pt idx="32">
                  <c:v>2.2999999999999998</c:v>
                </c:pt>
                <c:pt idx="33">
                  <c:v>0.6</c:v>
                </c:pt>
                <c:pt idx="34">
                  <c:v>30.9</c:v>
                </c:pt>
                <c:pt idx="35">
                  <c:v>0.2</c:v>
                </c:pt>
                <c:pt idx="36">
                  <c:v>23.2</c:v>
                </c:pt>
                <c:pt idx="37">
                  <c:v>24.3</c:v>
                </c:pt>
                <c:pt idx="38">
                  <c:v>19</c:v>
                </c:pt>
                <c:pt idx="39">
                  <c:v>0.4</c:v>
                </c:pt>
                <c:pt idx="40">
                  <c:v>86.9</c:v>
                </c:pt>
                <c:pt idx="41">
                  <c:v>39.799999999999997</c:v>
                </c:pt>
                <c:pt idx="42">
                  <c:v>54.7</c:v>
                </c:pt>
                <c:pt idx="43">
                  <c:v>4.5</c:v>
                </c:pt>
                <c:pt idx="44">
                  <c:v>50</c:v>
                </c:pt>
                <c:pt idx="45">
                  <c:v>11</c:v>
                </c:pt>
                <c:pt idx="46">
                  <c:v>6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1E8-4ACD-830A-1CBD8F7D937C}"/>
            </c:ext>
          </c:extLst>
        </c:ser>
        <c:ser>
          <c:idx val="1"/>
          <c:order val="1"/>
          <c:tx>
            <c:strRef>
              <c:f>SFMR!$F$1:$F$2</c:f>
              <c:strCache>
                <c:ptCount val="2"/>
                <c:pt idx="1">
                  <c:v>2018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accent3"/>
              </a:solidFill>
            </a:ln>
            <a:effectLst/>
          </c:spPr>
          <c:invertIfNegative val="0"/>
          <c:cat>
            <c:numRef>
              <c:f>SFMR!$D$3:$D$49</c:f>
              <c:numCache>
                <c:formatCode>General</c:formatCode>
                <c:ptCount val="4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</c:numCache>
            </c:numRef>
          </c:cat>
          <c:val>
            <c:numRef>
              <c:f>SFMR!$F$3:$F$49</c:f>
              <c:numCache>
                <c:formatCode>General</c:formatCode>
                <c:ptCount val="47"/>
                <c:pt idx="0">
                  <c:v>28.6</c:v>
                </c:pt>
                <c:pt idx="1">
                  <c:v>14.7</c:v>
                </c:pt>
                <c:pt idx="2">
                  <c:v>9.1</c:v>
                </c:pt>
                <c:pt idx="3">
                  <c:v>5.5</c:v>
                </c:pt>
                <c:pt idx="4">
                  <c:v>78.2</c:v>
                </c:pt>
                <c:pt idx="5">
                  <c:v>7</c:v>
                </c:pt>
                <c:pt idx="6">
                  <c:v>26</c:v>
                </c:pt>
                <c:pt idx="7">
                  <c:v>1</c:v>
                </c:pt>
                <c:pt idx="8">
                  <c:v>10.199999999999999</c:v>
                </c:pt>
                <c:pt idx="9">
                  <c:v>1.7</c:v>
                </c:pt>
                <c:pt idx="10">
                  <c:v>9.6</c:v>
                </c:pt>
                <c:pt idx="11">
                  <c:v>5.3</c:v>
                </c:pt>
                <c:pt idx="12">
                  <c:v>0</c:v>
                </c:pt>
                <c:pt idx="13">
                  <c:v>0.1</c:v>
                </c:pt>
                <c:pt idx="14">
                  <c:v>73.7</c:v>
                </c:pt>
                <c:pt idx="15">
                  <c:v>30</c:v>
                </c:pt>
                <c:pt idx="16">
                  <c:v>0.7</c:v>
                </c:pt>
                <c:pt idx="17">
                  <c:v>4.8</c:v>
                </c:pt>
                <c:pt idx="18">
                  <c:v>0.8</c:v>
                </c:pt>
                <c:pt idx="19">
                  <c:v>14.8</c:v>
                </c:pt>
                <c:pt idx="20">
                  <c:v>23.3</c:v>
                </c:pt>
                <c:pt idx="21">
                  <c:v>11.6</c:v>
                </c:pt>
                <c:pt idx="22">
                  <c:v>20.6</c:v>
                </c:pt>
                <c:pt idx="23">
                  <c:v>3</c:v>
                </c:pt>
                <c:pt idx="24">
                  <c:v>14.1</c:v>
                </c:pt>
                <c:pt idx="25">
                  <c:v>42.8</c:v>
                </c:pt>
                <c:pt idx="26">
                  <c:v>0.1</c:v>
                </c:pt>
                <c:pt idx="27">
                  <c:v>2.8</c:v>
                </c:pt>
                <c:pt idx="28">
                  <c:v>1.4</c:v>
                </c:pt>
                <c:pt idx="29">
                  <c:v>20.399999999999999</c:v>
                </c:pt>
                <c:pt idx="30">
                  <c:v>8.9</c:v>
                </c:pt>
                <c:pt idx="31">
                  <c:v>40.4</c:v>
                </c:pt>
                <c:pt idx="32">
                  <c:v>1.9</c:v>
                </c:pt>
                <c:pt idx="33">
                  <c:v>0.5</c:v>
                </c:pt>
                <c:pt idx="34">
                  <c:v>32.5</c:v>
                </c:pt>
                <c:pt idx="35">
                  <c:v>1.4</c:v>
                </c:pt>
                <c:pt idx="36">
                  <c:v>23.2</c:v>
                </c:pt>
                <c:pt idx="37">
                  <c:v>23.8</c:v>
                </c:pt>
                <c:pt idx="38">
                  <c:v>28.2</c:v>
                </c:pt>
                <c:pt idx="39">
                  <c:v>1</c:v>
                </c:pt>
                <c:pt idx="40">
                  <c:v>84.7</c:v>
                </c:pt>
                <c:pt idx="41">
                  <c:v>72.5</c:v>
                </c:pt>
                <c:pt idx="42">
                  <c:v>53.7</c:v>
                </c:pt>
                <c:pt idx="43">
                  <c:v>27.9</c:v>
                </c:pt>
                <c:pt idx="44">
                  <c:v>51.7</c:v>
                </c:pt>
                <c:pt idx="45">
                  <c:v>11.5</c:v>
                </c:pt>
                <c:pt idx="46">
                  <c:v>5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1E8-4ACD-830A-1CBD8F7D93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84170927"/>
        <c:axId val="948868703"/>
      </c:barChart>
      <c:catAx>
        <c:axId val="88417092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48868703"/>
        <c:crosses val="autoZero"/>
        <c:auto val="1"/>
        <c:lblAlgn val="ctr"/>
        <c:lblOffset val="100"/>
        <c:noMultiLvlLbl val="0"/>
      </c:catAx>
      <c:valAx>
        <c:axId val="948868703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8417092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5914407850847085"/>
          <c:y val="3.828073533615893E-2"/>
          <c:w val="0.14083067426383372"/>
          <c:h val="6.19392688899108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43DC77-A271-59F5-D55A-34C37773D89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827E775-A75E-72C3-8B29-D00DB28C30C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A3334CE-66D1-01BC-0892-9FDC7756E5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8F20D4A-A2B7-4470-09C6-6E85CF6E85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AD0B358-E515-6038-8FE4-CEE4867463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9797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D6F22B9-3D77-2A8E-3B09-6786753F0A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F10BF24-9BE9-32E4-7A83-A0DC2398BB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3299C77-A68E-BBA4-6FAE-7EB6DB5F7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5E6ECA1-0675-CEA1-77A3-B6B183A1B1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D217A69-7625-BA8D-A570-B257F8D64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5539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05D4B15-19F5-1B26-7E9A-BFCFB6EE434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776D627-F637-0A82-C18D-0CAA2B9F9B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4212BFC-389F-91B6-5510-932A6B27A1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AF69F6F-956E-B0C0-4E41-0B3D70EF4F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C9DA32D-9D7A-7090-5B44-486932F203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3360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34A640D-60D2-0DAB-326C-DAD962557E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9F33413-7D16-8BD1-159F-5783A08AE8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B9B6378-0983-38D7-C3F3-391E54065C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4360BA4-C8B4-E86D-DDBA-C96EAF3CC8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E5B040C-451A-3FDC-9815-78C46D36C1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01746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B812DA3-EAC7-0466-D0A7-74726EDDDA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8063543-00C5-F06C-F901-5F4736FF8D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C0C0D54-E11D-2100-1082-390CCB3AA1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E928D9F-4A3F-A193-0356-3A7FFD0CC6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58EDF2B-B3F8-7088-D440-177F6F0032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33543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BE370C3-7288-E156-4CDA-CD12C7B7C4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39AC83A-CCD3-CF9B-0842-9FA65EA0DDE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02069E7-CE31-B14E-8F15-725348EE97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3FF16AE-8A3E-46D7-ACD5-60223AAA50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60D6DD9-DFA9-DB84-AD1D-6D81E16B29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B0F7F54-6ABD-98FB-EBEE-BBAB12978F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61848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470DA7C-2594-6C9F-015A-D96E96EA4C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307476A-37D1-F63A-B228-1803DD9C1D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7329D0D-3C75-C050-9AA8-046501921D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396B8A3-F18B-FA21-3E7F-55B7CE264E4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95F0172-07E9-1BD1-4BE6-274DF4C468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A39993C-D8A7-86A7-419D-8CC9B9B90F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C920688-ABFA-3F8E-4ECA-27A58870F7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B328E0D-17D3-AA06-0F66-9FA3D9AB38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65123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1E4B0CF-A5B3-0B82-2CEC-39CDF30623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365D74F-64C2-A671-482B-553D8D371A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C484A4E-E892-278F-9ABA-B3B7D642E2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D527508-3A04-46BC-638E-1CF59DEB11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2625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D4C87BA-3A7F-83B6-2763-7F44FCED2A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EBF0517-E863-0C9E-AD5A-97E1DEB506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8E4E00F-1C47-9276-6B92-1112BD1691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89904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7E253E4-B1B1-3DB8-F98E-67A83577DB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33D5132-A9BE-D52F-5E9A-44869C6CFA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7E9A37D-6D13-4556-5993-EFD57CF2A9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0E6028F-C45A-C768-F3DF-1A3EBCE3AD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C257CB5-2ED2-E0FF-A6D9-11B1DEE2C6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816789D-CD1A-4DE9-5261-9B76E5A47E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54505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ADCE48B-160C-A889-6685-7D50FCE3F8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CD3D4F2-8379-7544-D556-9158BA6C169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EBE937E-A323-8E2F-91B8-6B6A2197C1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4343373-95E2-E9CA-DE03-BDF23F65BD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0194E29-7F03-0BF8-973F-56C22C696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416E4EE-F028-D2C6-7702-24616E674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76976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BE57FFD-B15E-6F48-E2AA-38710242DE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6D1A6F5-FCEB-53E1-DA29-F7D97EA11E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73D23F2-F598-4B43-7FAD-03E8CE7147C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23A2A1F-FDBB-B79D-0684-734F8655BF6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2495D6E-2C5B-2860-08A9-652075FE37F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1740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30A3FDFE-BEEF-3152-A16C-18D2F105958B}"/>
              </a:ext>
            </a:extLst>
          </p:cNvPr>
          <p:cNvGraphicFramePr>
            <a:graphicFrameLocks/>
          </p:cNvGraphicFramePr>
          <p:nvPr/>
        </p:nvGraphicFramePr>
        <p:xfrm>
          <a:off x="736969" y="606057"/>
          <a:ext cx="10924089" cy="48271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C1CD388-545A-192F-89FB-CEF78BF1FEBD}"/>
              </a:ext>
            </a:extLst>
          </p:cNvPr>
          <p:cNvSpPr txBox="1"/>
          <p:nvPr/>
        </p:nvSpPr>
        <p:spPr>
          <a:xfrm>
            <a:off x="5529178" y="5032775"/>
            <a:ext cx="1133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fecture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C835E470-3FCA-58AB-87EA-835CF1BC280C}"/>
              </a:ext>
            </a:extLst>
          </p:cNvPr>
          <p:cNvCxnSpPr>
            <a:cxnSpLocks/>
          </p:cNvCxnSpPr>
          <p:nvPr/>
        </p:nvCxnSpPr>
        <p:spPr>
          <a:xfrm>
            <a:off x="1166770" y="409302"/>
            <a:ext cx="11479" cy="422861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F80EF0B4-E62F-8AD4-D6B2-DAAC238C9284}"/>
              </a:ext>
            </a:extLst>
          </p:cNvPr>
          <p:cNvCxnSpPr>
            <a:cxnSpLocks/>
          </p:cNvCxnSpPr>
          <p:nvPr/>
        </p:nvCxnSpPr>
        <p:spPr>
          <a:xfrm flipH="1">
            <a:off x="1166770" y="4636481"/>
            <a:ext cx="1067973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7C87D15-3B11-889C-F62A-783F0800AA6D}"/>
              </a:ext>
            </a:extLst>
          </p:cNvPr>
          <p:cNvSpPr txBox="1"/>
          <p:nvPr/>
        </p:nvSpPr>
        <p:spPr>
          <a:xfrm>
            <a:off x="96718" y="2523608"/>
            <a:ext cx="73293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%</a:t>
            </a:r>
            <a:endParaRPr lang="ja-JP" altLang="en-US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A67A270-B103-E4AE-7951-9CBE082F86B2}"/>
              </a:ext>
            </a:extLst>
          </p:cNvPr>
          <p:cNvSpPr txBox="1"/>
          <p:nvPr/>
        </p:nvSpPr>
        <p:spPr>
          <a:xfrm>
            <a:off x="733425" y="5336034"/>
            <a:ext cx="10725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-FMR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chool-based fluoride mouth-rinse</a:t>
            </a:r>
            <a:endParaRPr kumimoji="1" lang="en-US" altLang="ja-JP" dirty="0">
              <a:highlight>
                <a:srgbClr val="FFFF00"/>
              </a:highligh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DD7EE14-426C-225C-B7F6-B44B5260A69F}"/>
              </a:ext>
            </a:extLst>
          </p:cNvPr>
          <p:cNvSpPr txBox="1"/>
          <p:nvPr/>
        </p:nvSpPr>
        <p:spPr>
          <a:xfrm>
            <a:off x="331695" y="6177180"/>
            <a:ext cx="11514812" cy="6771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The percentage of S-FMR among prefectures in Japan between 2016 to 2018</a:t>
            </a:r>
            <a:endParaRPr lang="en-US" altLang="ja-JP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ja-JP" altLang="en-US" sz="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gends: A figure shows the percentage of S-FMR trends in each prefecture between 2016 and 2018.</a:t>
            </a:r>
          </a:p>
        </p:txBody>
      </p:sp>
    </p:spTree>
    <p:extLst>
      <p:ext uri="{BB962C8B-B14F-4D97-AF65-F5344CB8AC3E}">
        <p14:creationId xmlns:p14="http://schemas.microsoft.com/office/powerpoint/2010/main" val="34598697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45</Words>
  <Application>Microsoft Office PowerPoint</Application>
  <PresentationFormat>ワイド画面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本貴文</dc:creator>
  <cp:lastModifiedBy>takafumi yamamoto</cp:lastModifiedBy>
  <cp:revision>5</cp:revision>
  <dcterms:created xsi:type="dcterms:W3CDTF">2023-12-07T06:34:18Z</dcterms:created>
  <dcterms:modified xsi:type="dcterms:W3CDTF">2024-02-12T23:18:23Z</dcterms:modified>
</cp:coreProperties>
</file>